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vertBarState="maximized" horzBarState="maximized">
    <p:restoredLeft sz="15620"/>
    <p:restoredTop sz="94620" autoAdjust="0"/>
  </p:normalViewPr>
  <p:slideViewPr>
    <p:cSldViewPr>
      <p:cViewPr>
        <p:scale>
          <a:sx n="130" d="100"/>
          <a:sy n="130" d="100"/>
        </p:scale>
        <p:origin x="-269" y="370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66E8B17-2A18-4C88-B6C6-9E96F9884686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66F0FE8-BF86-4FFD-B94A-C276603E386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41316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88572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37882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411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50964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93000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3040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9385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86483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8420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16393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9864967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1FD11-C891-4852-A462-4BD2720EC7C1}" type="datetimeFigureOut">
              <a:rPr lang="en-CA" smtClean="0"/>
              <a:t>28/09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57BE9-BF90-4075-A23A-AEBEC71E439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60791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934426" y="6280002"/>
            <a:ext cx="5092595" cy="20005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.</a:t>
            </a:r>
            <a:r>
              <a:rPr lang="en-CA" sz="1200" b="1" dirty="0" smtClean="0">
                <a:latin typeface="New Times Roman"/>
              </a:rPr>
              <a:t>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 </a:t>
            </a:r>
            <a:r>
              <a:rPr lang="en-CA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 NMR spectra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ve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olesterol signature peaks in serial dilutions of growth supplement sample in aqueous solution: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A, B, C, D show the spectrum at 1:10,000, 1:1,000, 1:100 and 1:10 dilutions of growth supplement samples in aqueous solutions. Panel E shows the reference cholesterol spectrum with three signature peaks that have unique chemical shift for cholesterol. These are indicated asterisk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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riangle (</a:t>
            </a:r>
            <a:r>
              <a:rPr lang="az-Cyrl-AZ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▲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rectangle  (◘) at 5.38, 3.55 and 0.7 ppm,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sed circle ( </a:t>
            </a:r>
            <a:r>
              <a:rPr lang="en-CA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 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the peak for satellite cholesterol  from chloroform at 7.5-7.0 ppm.</a:t>
            </a:r>
          </a:p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CA" sz="1200" dirty="0">
              <a:latin typeface="New Times Roman"/>
            </a:endParaRPr>
          </a:p>
          <a:p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CA" sz="1200" dirty="0">
              <a:latin typeface="New Times Roman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859820" y="755576"/>
            <a:ext cx="5120901" cy="5460957"/>
            <a:chOff x="859820" y="755576"/>
            <a:chExt cx="5120901" cy="5460957"/>
          </a:xfrm>
        </p:grpSpPr>
        <p:grpSp>
          <p:nvGrpSpPr>
            <p:cNvPr id="28" name="Group 27"/>
            <p:cNvGrpSpPr/>
            <p:nvPr/>
          </p:nvGrpSpPr>
          <p:grpSpPr>
            <a:xfrm>
              <a:off x="859820" y="755576"/>
              <a:ext cx="5120901" cy="5328592"/>
              <a:chOff x="859820" y="755576"/>
              <a:chExt cx="5120901" cy="5328592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/>
              <a:srcRect l="15350" t="11675" r="15350" b="12200"/>
              <a:stretch/>
            </p:blipFill>
            <p:spPr>
              <a:xfrm>
                <a:off x="980728" y="755576"/>
                <a:ext cx="4999993" cy="5328592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859820" y="2813459"/>
                <a:ext cx="2160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b="1" dirty="0" smtClean="0">
                    <a:latin typeface="New Times Roman"/>
                  </a:rPr>
                  <a:t>C</a:t>
                </a:r>
                <a:endParaRPr lang="en-CA" sz="1200" b="1" dirty="0">
                  <a:latin typeface="New Times Roman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859820" y="1730882"/>
                <a:ext cx="2160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b="1" dirty="0" smtClean="0">
                    <a:latin typeface="New Times Roman"/>
                  </a:rPr>
                  <a:t>B</a:t>
                </a:r>
                <a:endParaRPr lang="en-CA" sz="1200" b="1" dirty="0">
                  <a:latin typeface="New Times Roman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859820" y="928364"/>
                <a:ext cx="2160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b="1" dirty="0" smtClean="0">
                    <a:latin typeface="New Times Roman"/>
                  </a:rPr>
                  <a:t>A</a:t>
                </a:r>
                <a:endParaRPr lang="en-CA" sz="1200" b="1" dirty="0">
                  <a:latin typeface="New Times Roman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859820" y="3757536"/>
                <a:ext cx="2160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b="1" dirty="0" smtClean="0">
                    <a:latin typeface="New Times Roman"/>
                  </a:rPr>
                  <a:t>D</a:t>
                </a:r>
                <a:endParaRPr lang="en-CA" sz="1200" b="1" dirty="0">
                  <a:latin typeface="New Times Roman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859820" y="4701613"/>
                <a:ext cx="21602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200" b="1" dirty="0" smtClean="0">
                    <a:latin typeface="New Times Roman"/>
                  </a:rPr>
                  <a:t>E</a:t>
                </a:r>
                <a:endParaRPr lang="en-CA" sz="1200" b="1" dirty="0">
                  <a:latin typeface="New Times Roman"/>
                </a:endParaRPr>
              </a:p>
            </p:txBody>
          </p:sp>
          <p:grpSp>
            <p:nvGrpSpPr>
              <p:cNvPr id="10" name="Group 9"/>
              <p:cNvGrpSpPr/>
              <p:nvPr/>
            </p:nvGrpSpPr>
            <p:grpSpPr>
              <a:xfrm>
                <a:off x="2537286" y="4860032"/>
                <a:ext cx="179808" cy="400110"/>
                <a:chOff x="1981851" y="2413477"/>
                <a:chExt cx="179808" cy="400110"/>
              </a:xfrm>
            </p:grpSpPr>
            <p:grpSp>
              <p:nvGrpSpPr>
                <p:cNvPr id="11" name="Group 10"/>
                <p:cNvGrpSpPr/>
                <p:nvPr/>
              </p:nvGrpSpPr>
              <p:grpSpPr>
                <a:xfrm>
                  <a:off x="2079315" y="2627784"/>
                  <a:ext cx="80131" cy="72008"/>
                  <a:chOff x="2079315" y="2627784"/>
                  <a:chExt cx="80131" cy="72008"/>
                </a:xfrm>
              </p:grpSpPr>
              <p:cxnSp>
                <p:nvCxnSpPr>
                  <p:cNvPr id="13" name="Straight Connector 12"/>
                  <p:cNvCxnSpPr/>
                  <p:nvPr/>
                </p:nvCxnSpPr>
                <p:spPr>
                  <a:xfrm>
                    <a:off x="2079315" y="2627784"/>
                    <a:ext cx="801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Connector 13"/>
                  <p:cNvCxnSpPr/>
                  <p:nvPr/>
                </p:nvCxnSpPr>
                <p:spPr>
                  <a:xfrm>
                    <a:off x="2079315" y="2627784"/>
                    <a:ext cx="0" cy="720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Straight Connector 14"/>
                  <p:cNvCxnSpPr/>
                  <p:nvPr/>
                </p:nvCxnSpPr>
                <p:spPr>
                  <a:xfrm>
                    <a:off x="2157822" y="2627784"/>
                    <a:ext cx="0" cy="720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" name="TextBox 11"/>
                <p:cNvSpPr txBox="1"/>
                <p:nvPr/>
              </p:nvSpPr>
              <p:spPr>
                <a:xfrm>
                  <a:off x="1981851" y="2413477"/>
                  <a:ext cx="1798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CA" sz="2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CA" sz="2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3687695" y="5123878"/>
                <a:ext cx="80131" cy="167217"/>
                <a:chOff x="4149080" y="732375"/>
                <a:chExt cx="80131" cy="167217"/>
              </a:xfrm>
            </p:grpSpPr>
            <p:grpSp>
              <p:nvGrpSpPr>
                <p:cNvPr id="17" name="Group 16"/>
                <p:cNvGrpSpPr/>
                <p:nvPr/>
              </p:nvGrpSpPr>
              <p:grpSpPr>
                <a:xfrm>
                  <a:off x="4149080" y="827584"/>
                  <a:ext cx="80131" cy="72008"/>
                  <a:chOff x="2079315" y="2627784"/>
                  <a:chExt cx="80131" cy="72008"/>
                </a:xfrm>
              </p:grpSpPr>
              <p:cxnSp>
                <p:nvCxnSpPr>
                  <p:cNvPr id="19" name="Straight Connector 18"/>
                  <p:cNvCxnSpPr/>
                  <p:nvPr/>
                </p:nvCxnSpPr>
                <p:spPr>
                  <a:xfrm>
                    <a:off x="2079315" y="2627784"/>
                    <a:ext cx="801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Connector 19"/>
                  <p:cNvCxnSpPr/>
                  <p:nvPr/>
                </p:nvCxnSpPr>
                <p:spPr>
                  <a:xfrm>
                    <a:off x="2079315" y="2627784"/>
                    <a:ext cx="0" cy="720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Connector 20"/>
                  <p:cNvCxnSpPr/>
                  <p:nvPr/>
                </p:nvCxnSpPr>
                <p:spPr>
                  <a:xfrm>
                    <a:off x="2157822" y="2627784"/>
                    <a:ext cx="0" cy="720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8" name="Isosceles Triangle 17"/>
                <p:cNvSpPr/>
                <p:nvPr/>
              </p:nvSpPr>
              <p:spPr>
                <a:xfrm>
                  <a:off x="4174629" y="732375"/>
                  <a:ext cx="45719" cy="45719"/>
                </a:xfrm>
                <a:prstGeom prst="triangl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  <p:grpSp>
            <p:nvGrpSpPr>
              <p:cNvPr id="22" name="Group 21"/>
              <p:cNvGrpSpPr/>
              <p:nvPr/>
            </p:nvGrpSpPr>
            <p:grpSpPr>
              <a:xfrm>
                <a:off x="5301208" y="4752937"/>
                <a:ext cx="80131" cy="174349"/>
                <a:chOff x="4941168" y="2008287"/>
                <a:chExt cx="80131" cy="174349"/>
              </a:xfrm>
            </p:grpSpPr>
            <p:grpSp>
              <p:nvGrpSpPr>
                <p:cNvPr id="23" name="Group 22"/>
                <p:cNvGrpSpPr/>
                <p:nvPr/>
              </p:nvGrpSpPr>
              <p:grpSpPr>
                <a:xfrm>
                  <a:off x="4941168" y="2110628"/>
                  <a:ext cx="80131" cy="72008"/>
                  <a:chOff x="2079315" y="2627784"/>
                  <a:chExt cx="80131" cy="72008"/>
                </a:xfrm>
              </p:grpSpPr>
              <p:cxnSp>
                <p:nvCxnSpPr>
                  <p:cNvPr id="25" name="Straight Connector 24"/>
                  <p:cNvCxnSpPr/>
                  <p:nvPr/>
                </p:nvCxnSpPr>
                <p:spPr>
                  <a:xfrm>
                    <a:off x="2079315" y="2627784"/>
                    <a:ext cx="8013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Connector 25"/>
                  <p:cNvCxnSpPr/>
                  <p:nvPr/>
                </p:nvCxnSpPr>
                <p:spPr>
                  <a:xfrm>
                    <a:off x="2079315" y="2627784"/>
                    <a:ext cx="0" cy="720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Connector 26"/>
                  <p:cNvCxnSpPr/>
                  <p:nvPr/>
                </p:nvCxnSpPr>
                <p:spPr>
                  <a:xfrm>
                    <a:off x="2157822" y="2627784"/>
                    <a:ext cx="0" cy="72008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" name="Rounded Rectangle 23"/>
                <p:cNvSpPr/>
                <p:nvPr/>
              </p:nvSpPr>
              <p:spPr>
                <a:xfrm>
                  <a:off x="4958025" y="2008287"/>
                  <a:ext cx="46415" cy="45719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/>
                </a:p>
              </p:txBody>
            </p:sp>
          </p:grpSp>
        </p:grpSp>
        <p:grpSp>
          <p:nvGrpSpPr>
            <p:cNvPr id="35" name="Group 34"/>
            <p:cNvGrpSpPr/>
            <p:nvPr/>
          </p:nvGrpSpPr>
          <p:grpSpPr>
            <a:xfrm>
              <a:off x="1445658" y="4644767"/>
              <a:ext cx="195460" cy="307777"/>
              <a:chOff x="278404" y="5436096"/>
              <a:chExt cx="195460" cy="307777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278404" y="5436096"/>
                <a:ext cx="1954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●</a:t>
                </a:r>
                <a:endParaRPr lang="en-CA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1" name="Group 30"/>
              <p:cNvGrpSpPr/>
              <p:nvPr/>
            </p:nvGrpSpPr>
            <p:grpSpPr>
              <a:xfrm>
                <a:off x="375977" y="5671865"/>
                <a:ext cx="80131" cy="72008"/>
                <a:chOff x="2079315" y="2627784"/>
                <a:chExt cx="80131" cy="72008"/>
              </a:xfrm>
            </p:grpSpPr>
            <p:cxnSp>
              <p:nvCxnSpPr>
                <p:cNvPr id="32" name="Straight Connector 31"/>
                <p:cNvCxnSpPr/>
                <p:nvPr/>
              </p:nvCxnSpPr>
              <p:spPr>
                <a:xfrm>
                  <a:off x="2079315" y="2627784"/>
                  <a:ext cx="8013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2079315" y="2627784"/>
                  <a:ext cx="0" cy="7200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/>
                <p:cNvCxnSpPr/>
                <p:nvPr/>
              </p:nvCxnSpPr>
              <p:spPr>
                <a:xfrm>
                  <a:off x="2157822" y="2627784"/>
                  <a:ext cx="0" cy="7200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6" name="TextBox 35"/>
            <p:cNvSpPr txBox="1"/>
            <p:nvPr/>
          </p:nvSpPr>
          <p:spPr>
            <a:xfrm>
              <a:off x="2351045" y="5939534"/>
              <a:ext cx="22593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 </a:t>
              </a:r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proton) </a:t>
              </a:r>
              <a:r>
                <a:rPr lang="en-CA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emical shift at ppm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56094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9</TotalTime>
  <Words>132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  <Company/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6-09-23T17:42:28Z</cp:lastPrinted>
</cp:coreProperties>
</file>